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63" r:id="rId3"/>
    <p:sldId id="264" r:id="rId4"/>
    <p:sldId id="265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5" d="100"/>
          <a:sy n="85" d="100"/>
        </p:scale>
        <p:origin x="140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17C9C-F2AE-41A8-B3D1-5B3B97F8A11E}" type="datetimeFigureOut">
              <a:rPr lang="en-IN" smtClean="0"/>
              <a:t>07-08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588E7-7109-4417-ACBB-297D079FF0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410537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17C9C-F2AE-41A8-B3D1-5B3B97F8A11E}" type="datetimeFigureOut">
              <a:rPr lang="en-IN" smtClean="0"/>
              <a:t>07-08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588E7-7109-4417-ACBB-297D079FF0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905746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17C9C-F2AE-41A8-B3D1-5B3B97F8A11E}" type="datetimeFigureOut">
              <a:rPr lang="en-IN" smtClean="0"/>
              <a:t>07-08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588E7-7109-4417-ACBB-297D079FF0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15785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17C9C-F2AE-41A8-B3D1-5B3B97F8A11E}" type="datetimeFigureOut">
              <a:rPr lang="en-IN" smtClean="0"/>
              <a:t>07-08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588E7-7109-4417-ACBB-297D079FF0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73476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17C9C-F2AE-41A8-B3D1-5B3B97F8A11E}" type="datetimeFigureOut">
              <a:rPr lang="en-IN" smtClean="0"/>
              <a:t>07-08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588E7-7109-4417-ACBB-297D079FF0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7970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17C9C-F2AE-41A8-B3D1-5B3B97F8A11E}" type="datetimeFigureOut">
              <a:rPr lang="en-IN" smtClean="0"/>
              <a:t>07-08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588E7-7109-4417-ACBB-297D079FF0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544686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17C9C-F2AE-41A8-B3D1-5B3B97F8A11E}" type="datetimeFigureOut">
              <a:rPr lang="en-IN" smtClean="0"/>
              <a:t>07-08-20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588E7-7109-4417-ACBB-297D079FF0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792640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17C9C-F2AE-41A8-B3D1-5B3B97F8A11E}" type="datetimeFigureOut">
              <a:rPr lang="en-IN" smtClean="0"/>
              <a:t>07-08-20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588E7-7109-4417-ACBB-297D079FF0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462563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17C9C-F2AE-41A8-B3D1-5B3B97F8A11E}" type="datetimeFigureOut">
              <a:rPr lang="en-IN" smtClean="0"/>
              <a:t>07-08-20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588E7-7109-4417-ACBB-297D079FF0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356749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17C9C-F2AE-41A8-B3D1-5B3B97F8A11E}" type="datetimeFigureOut">
              <a:rPr lang="en-IN" smtClean="0"/>
              <a:t>07-08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588E7-7109-4417-ACBB-297D079FF0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663925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17C9C-F2AE-41A8-B3D1-5B3B97F8A11E}" type="datetimeFigureOut">
              <a:rPr lang="en-IN" smtClean="0"/>
              <a:t>07-08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588E7-7109-4417-ACBB-297D079FF0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37476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D17C9C-F2AE-41A8-B3D1-5B3B97F8A11E}" type="datetimeFigureOut">
              <a:rPr lang="en-IN" smtClean="0"/>
              <a:t>07-08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3588E7-7109-4417-ACBB-297D079FF0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37683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D6E18C2-DFC7-4818-9D9F-3730B1AA6826}"/>
              </a:ext>
            </a:extLst>
          </p:cNvPr>
          <p:cNvSpPr/>
          <p:nvPr/>
        </p:nvSpPr>
        <p:spPr>
          <a:xfrm>
            <a:off x="3737223" y="33283"/>
            <a:ext cx="2248135" cy="2766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</a:t>
            </a:r>
            <a:endParaRPr lang="en-IN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C89CD13-2C6D-467E-9A3A-0A55D98A0EB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80" r="5968"/>
          <a:stretch/>
        </p:blipFill>
        <p:spPr bwMode="auto">
          <a:xfrm>
            <a:off x="210983" y="503731"/>
            <a:ext cx="4443464" cy="25542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8EA7495-5183-452F-9461-9E19992E2EF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65" r="2108"/>
          <a:stretch/>
        </p:blipFill>
        <p:spPr bwMode="auto">
          <a:xfrm>
            <a:off x="4624466" y="503731"/>
            <a:ext cx="4489554" cy="24616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5">
            <a:extLst>
              <a:ext uri="{FF2B5EF4-FFF2-40B4-BE49-F238E27FC236}">
                <a16:creationId xmlns:a16="http://schemas.microsoft.com/office/drawing/2014/main" id="{6BCCDCBD-AFD1-4926-9DCD-B8FD273A0C9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879" y="3159180"/>
            <a:ext cx="4691499" cy="24416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27F1DBC-F195-4792-BB17-CA02BAC1772B}"/>
              </a:ext>
            </a:extLst>
          </p:cNvPr>
          <p:cNvSpPr txBox="1"/>
          <p:nvPr/>
        </p:nvSpPr>
        <p:spPr>
          <a:xfrm>
            <a:off x="67879" y="226419"/>
            <a:ext cx="5141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" panose="02020603060405020304" pitchFamily="18" charset="0"/>
              </a:rPr>
              <a:t>(A)                                                                        (B)</a:t>
            </a:r>
            <a:endParaRPr lang="en-IN" b="1" dirty="0">
              <a:latin typeface="Times" panose="0202060306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B270BC8-A52C-476F-88D1-998C50412222}"/>
              </a:ext>
            </a:extLst>
          </p:cNvPr>
          <p:cNvSpPr txBox="1"/>
          <p:nvPr/>
        </p:nvSpPr>
        <p:spPr>
          <a:xfrm>
            <a:off x="85369" y="2919652"/>
            <a:ext cx="5629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" panose="02020603060405020304" pitchFamily="18" charset="0"/>
              </a:rPr>
              <a:t>(C) </a:t>
            </a:r>
            <a:endParaRPr lang="en-IN" b="1" dirty="0">
              <a:latin typeface="Times" panose="0202060306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32436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>
            <a:extLst>
              <a:ext uri="{FF2B5EF4-FFF2-40B4-BE49-F238E27FC236}">
                <a16:creationId xmlns:a16="http://schemas.microsoft.com/office/drawing/2014/main" id="{166F51F4-17B0-408D-B468-DDDC77E5630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041" y="600632"/>
            <a:ext cx="4497048" cy="2230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6">
            <a:extLst>
              <a:ext uri="{FF2B5EF4-FFF2-40B4-BE49-F238E27FC236}">
                <a16:creationId xmlns:a16="http://schemas.microsoft.com/office/drawing/2014/main" id="{42A89568-A994-4EDB-96E7-B8822BA8C9B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585" y="3121917"/>
            <a:ext cx="5095635" cy="2456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6">
            <a:extLst>
              <a:ext uri="{FF2B5EF4-FFF2-40B4-BE49-F238E27FC236}">
                <a16:creationId xmlns:a16="http://schemas.microsoft.com/office/drawing/2014/main" id="{C431071A-CFBE-4AFA-866C-72C08501F31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7" r="11121"/>
          <a:stretch/>
        </p:blipFill>
        <p:spPr bwMode="auto">
          <a:xfrm>
            <a:off x="4784481" y="603833"/>
            <a:ext cx="4284567" cy="22892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0B2C528C-E18F-47E2-9698-71A033788B0E}"/>
              </a:ext>
            </a:extLst>
          </p:cNvPr>
          <p:cNvSpPr/>
          <p:nvPr/>
        </p:nvSpPr>
        <p:spPr>
          <a:xfrm>
            <a:off x="3737223" y="33283"/>
            <a:ext cx="2248135" cy="2766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</a:t>
            </a:r>
            <a:endParaRPr lang="en-IN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194A548-4494-4E3C-852A-116C6AE8A9FF}"/>
              </a:ext>
            </a:extLst>
          </p:cNvPr>
          <p:cNvSpPr txBox="1"/>
          <p:nvPr/>
        </p:nvSpPr>
        <p:spPr>
          <a:xfrm>
            <a:off x="67879" y="226419"/>
            <a:ext cx="5141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" panose="02020603060405020304" pitchFamily="18" charset="0"/>
              </a:rPr>
              <a:t>(A)                                                                        (B)</a:t>
            </a:r>
            <a:endParaRPr lang="en-IN" b="1" dirty="0">
              <a:latin typeface="Times" panose="0202060306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385C1EA-60AC-41B9-9B49-F591236C41F3}"/>
              </a:ext>
            </a:extLst>
          </p:cNvPr>
          <p:cNvSpPr txBox="1"/>
          <p:nvPr/>
        </p:nvSpPr>
        <p:spPr>
          <a:xfrm>
            <a:off x="85369" y="2919652"/>
            <a:ext cx="5629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" panose="02020603060405020304" pitchFamily="18" charset="0"/>
              </a:rPr>
              <a:t>(C) </a:t>
            </a:r>
            <a:endParaRPr lang="en-IN" b="1" dirty="0">
              <a:latin typeface="Times" panose="0202060306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62148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6">
            <a:extLst>
              <a:ext uri="{FF2B5EF4-FFF2-40B4-BE49-F238E27FC236}">
                <a16:creationId xmlns:a16="http://schemas.microsoft.com/office/drawing/2014/main" id="{642446AB-C325-4BD4-A28C-D831F360CEB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4265" y="457943"/>
            <a:ext cx="6215588" cy="3190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A414B75-804E-4227-87CE-7D5096E2831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8590" y="3429000"/>
            <a:ext cx="6111263" cy="31279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1D4409B4-9B4E-4492-84FC-83B9BB3F5068}"/>
              </a:ext>
            </a:extLst>
          </p:cNvPr>
          <p:cNvSpPr/>
          <p:nvPr/>
        </p:nvSpPr>
        <p:spPr>
          <a:xfrm>
            <a:off x="3737223" y="33283"/>
            <a:ext cx="2248135" cy="2766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</a:t>
            </a:r>
            <a:endParaRPr lang="en-IN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49F8790-D46D-4A79-9A14-2154F64E2C37}"/>
              </a:ext>
            </a:extLst>
          </p:cNvPr>
          <p:cNvSpPr txBox="1"/>
          <p:nvPr/>
        </p:nvSpPr>
        <p:spPr>
          <a:xfrm>
            <a:off x="844207" y="457943"/>
            <a:ext cx="1544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" panose="02020603060405020304" pitchFamily="18" charset="0"/>
              </a:rPr>
              <a:t>(A)                  </a:t>
            </a:r>
            <a:endParaRPr lang="en-IN" b="1" dirty="0">
              <a:latin typeface="Times" panose="0202060306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2491959-91F4-4710-85F5-81ABB7542CA3}"/>
              </a:ext>
            </a:extLst>
          </p:cNvPr>
          <p:cNvSpPr txBox="1"/>
          <p:nvPr/>
        </p:nvSpPr>
        <p:spPr>
          <a:xfrm>
            <a:off x="978677" y="3443193"/>
            <a:ext cx="1531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" panose="02020603060405020304" pitchFamily="18" charset="0"/>
              </a:rPr>
              <a:t>(B)                  </a:t>
            </a:r>
            <a:endParaRPr lang="en-IN" b="1" dirty="0">
              <a:latin typeface="Times" panose="0202060306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10799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5">
            <a:extLst>
              <a:ext uri="{FF2B5EF4-FFF2-40B4-BE49-F238E27FC236}">
                <a16:creationId xmlns:a16="http://schemas.microsoft.com/office/drawing/2014/main" id="{24313F66-A72D-44EE-ABE6-C4F5A71EA9B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312" y="996118"/>
            <a:ext cx="8564141" cy="44425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09C92B3B-DFBC-4954-B274-8CB4D014D471}"/>
              </a:ext>
            </a:extLst>
          </p:cNvPr>
          <p:cNvSpPr/>
          <p:nvPr/>
        </p:nvSpPr>
        <p:spPr>
          <a:xfrm>
            <a:off x="3737223" y="33283"/>
            <a:ext cx="2248135" cy="2766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GB" sz="1200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4</a:t>
            </a:r>
            <a:endParaRPr lang="en-IN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6870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20</TotalTime>
  <Words>36</Words>
  <Application>Microsoft Office PowerPoint</Application>
  <PresentationFormat>On-screen Show (4:3)</PresentationFormat>
  <Paragraphs>1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Dell</cp:lastModifiedBy>
  <cp:revision>29</cp:revision>
  <dcterms:created xsi:type="dcterms:W3CDTF">2023-11-08T14:18:52Z</dcterms:created>
  <dcterms:modified xsi:type="dcterms:W3CDTF">2024-08-07T10:10:27Z</dcterms:modified>
</cp:coreProperties>
</file>